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372" y="108"/>
      </p:cViewPr>
      <p:guideLst>
        <p:guide orient="horz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47548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55180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07988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455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07158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36120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61221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67053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26164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75164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55279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8B0E4-1DA4-4350-B3B4-AF8297FF3A35}" type="datetimeFigureOut">
              <a:rPr lang="nl-NL" smtClean="0"/>
              <a:t>5-7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884B7-1BD7-4B48-A111-C4CC26674F6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67858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02099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73309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35414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12363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587527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079802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125239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726273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790468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9600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-1"/>
            <a:ext cx="12295447" cy="6916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00719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25664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67673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56817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49382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76390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35720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1073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0</Words>
  <Application>Microsoft Office PowerPoint</Application>
  <PresentationFormat>Widescreen</PresentationFormat>
  <Paragraphs>0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aastricht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iken, J (GEN)</dc:creator>
  <cp:lastModifiedBy>Luiken, J (GEN)</cp:lastModifiedBy>
  <cp:revision>8</cp:revision>
  <dcterms:created xsi:type="dcterms:W3CDTF">2021-07-05T09:19:00Z</dcterms:created>
  <dcterms:modified xsi:type="dcterms:W3CDTF">2021-07-05T11:54:57Z</dcterms:modified>
</cp:coreProperties>
</file>